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7544" autoAdjust="0"/>
  </p:normalViewPr>
  <p:slideViewPr>
    <p:cSldViewPr snapToGrid="0">
      <p:cViewPr varScale="1">
        <p:scale>
          <a:sx n="99" d="100"/>
          <a:sy n="99" d="100"/>
        </p:scale>
        <p:origin x="1980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B8EC77-E24E-4FC5-8D38-EBCC3E952000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4A1D5-24A7-4630-A8E5-4EEEAFA59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76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. Comparison of antigenemia between upper and lower respiratory specimens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44A1D5-24A7-4630-A8E5-4EEEAFA596B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8038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678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261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5589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258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762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9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08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741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913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71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1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32392-CCF6-4193-9C56-062F58E1F121}" type="datetimeFigureOut">
              <a:rPr lang="en-US" smtClean="0"/>
              <a:t>4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40C792-C8EB-483C-BD99-A715A5090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661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6296" y="162012"/>
            <a:ext cx="5871019" cy="4404767"/>
          </a:xfrm>
          <a:prstGeom prst="rect">
            <a:avLst/>
          </a:prstGeom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276925"/>
              </p:ext>
            </p:extLst>
          </p:nvPr>
        </p:nvGraphicFramePr>
        <p:xfrm>
          <a:off x="1090662" y="4331970"/>
          <a:ext cx="6898306" cy="15544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4416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312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411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0383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0852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dirty="0">
                          <a:effectLst/>
                        </a:rPr>
                        <a:t>Variable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dirty="0">
                          <a:effectLst/>
                        </a:rPr>
                        <a:t>AUC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dirty="0">
                          <a:effectLst/>
                        </a:rPr>
                        <a:t>95% CI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b="1" i="1" kern="1200" dirty="0"/>
                        <a:t>P-</a:t>
                      </a:r>
                      <a:r>
                        <a:rPr lang="en-US" altLang="ko-KR" sz="1100" b="1" kern="1200" dirty="0"/>
                        <a:t>Value</a:t>
                      </a:r>
                      <a:endParaRPr lang="en-US" altLang="ko-KR" sz="11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fontAlgn="b"/>
                      <a:endParaRPr lang="en-US" sz="1000" dirty="0">
                        <a:effectLst/>
                      </a:endParaRPr>
                    </a:p>
                  </a:txBody>
                  <a:tcPr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Antigenemia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/>
                        <a:t>0.831</a:t>
                      </a:r>
                      <a:endParaRPr lang="en-US" sz="1100" b="1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</a:rPr>
                        <a:t>0.759</a:t>
                      </a:r>
                      <a:r>
                        <a:rPr lang="en-US" sz="1100" b="1" kern="0" spc="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</a:rPr>
                        <a:t>–</a:t>
                      </a:r>
                      <a:r>
                        <a:rPr lang="en-US" sz="1100" b="1" dirty="0">
                          <a:effectLst/>
                        </a:rPr>
                        <a:t>0.888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Antigenemia ~ E gene - nasopharynx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effectLst/>
                        </a:rPr>
                        <a:t>P</a:t>
                      </a:r>
                      <a:r>
                        <a:rPr lang="en-US" sz="1100" b="1" dirty="0">
                          <a:effectLst/>
                        </a:rPr>
                        <a:t> &lt;0.0001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E gene - nasopharyn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0.970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</a:rPr>
                        <a:t>0.927</a:t>
                      </a:r>
                      <a:r>
                        <a:rPr lang="en-US" sz="1100" b="1" kern="0" spc="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</a:rPr>
                        <a:t>–</a:t>
                      </a:r>
                      <a:r>
                        <a:rPr lang="en-US" sz="1100" b="1" dirty="0">
                          <a:effectLst/>
                        </a:rPr>
                        <a:t>0.991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Antigenemia ~ E gene - sputu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effectLst/>
                        </a:rPr>
                        <a:t>P</a:t>
                      </a:r>
                      <a:r>
                        <a:rPr lang="en-US" sz="1100" b="1" dirty="0">
                          <a:effectLst/>
                        </a:rPr>
                        <a:t>=0.0012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E gene  -Sputum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0.911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</a:rPr>
                        <a:t>0.852</a:t>
                      </a:r>
                      <a:r>
                        <a:rPr lang="en-US" sz="1100" b="1" kern="0" spc="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</a:rPr>
                        <a:t>–</a:t>
                      </a:r>
                      <a:r>
                        <a:rPr lang="en-US" sz="1100" b="1" dirty="0">
                          <a:effectLst/>
                        </a:rPr>
                        <a:t>0.952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Antigenemia ~ RdRp gene - nasopharyn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effectLst/>
                        </a:rPr>
                        <a:t>P</a:t>
                      </a:r>
                      <a:r>
                        <a:rPr lang="en-US" sz="1100" b="1" dirty="0">
                          <a:effectLst/>
                        </a:rPr>
                        <a:t> &lt;0.0001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RdRp - nasopharyn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0.953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</a:rPr>
                        <a:t>0.905</a:t>
                      </a:r>
                      <a:r>
                        <a:rPr lang="en-US" sz="1100" b="1" kern="0" spc="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</a:rPr>
                        <a:t>–</a:t>
                      </a:r>
                      <a:r>
                        <a:rPr lang="en-US" sz="1100" b="1" dirty="0">
                          <a:effectLst/>
                        </a:rPr>
                        <a:t>0.982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Antigenemia ~ RdRp gene - sputum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effectLst/>
                        </a:rPr>
                        <a:t>P</a:t>
                      </a:r>
                      <a:r>
                        <a:rPr lang="en-US" sz="1100" b="1" dirty="0">
                          <a:effectLst/>
                        </a:rPr>
                        <a:t>=0.0012</a:t>
                      </a:r>
                      <a:endParaRPr lang="en-US" sz="1100" b="1" dirty="0">
                        <a:effectLst/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7525">
                <a:tc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RdRp - Sputum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0.911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effectLst/>
                        </a:rPr>
                        <a:t>0.852</a:t>
                      </a:r>
                      <a:r>
                        <a:rPr lang="en-US" sz="1100" b="1" kern="0" spc="0" dirty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</a:rPr>
                        <a:t>–</a:t>
                      </a:r>
                      <a:r>
                        <a:rPr lang="en-US" sz="1100" b="1" dirty="0">
                          <a:effectLst/>
                        </a:rPr>
                        <a:t>0.952</a:t>
                      </a:r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9766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26</TotalTime>
  <Words>82</Words>
  <Application>Microsoft Office PowerPoint</Application>
  <PresentationFormat>화면 슬라이드 쇼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pmjlal@gmail.com</dc:creator>
  <cp:lastModifiedBy>user</cp:lastModifiedBy>
  <cp:revision>157</cp:revision>
  <dcterms:created xsi:type="dcterms:W3CDTF">2022-01-23T11:45:45Z</dcterms:created>
  <dcterms:modified xsi:type="dcterms:W3CDTF">2024-04-26T03:53:16Z</dcterms:modified>
</cp:coreProperties>
</file>